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08" r:id="rId2"/>
  </p:sldIdLst>
  <p:sldSz cx="6858000" cy="9906000" type="A4"/>
  <p:notesSz cx="9931400" cy="6794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0" userDrawn="1">
          <p15:clr>
            <a:srgbClr val="A4A3A4"/>
          </p15:clr>
        </p15:guide>
        <p15:guide id="2" pos="391" userDrawn="1">
          <p15:clr>
            <a:srgbClr val="A4A3A4"/>
          </p15:clr>
        </p15:guide>
        <p15:guide id="6" orient="horz" pos="6136" userDrawn="1">
          <p15:clr>
            <a:srgbClr val="A4A3A4"/>
          </p15:clr>
        </p15:guide>
        <p15:guide id="7" pos="3884" userDrawn="1">
          <p15:clr>
            <a:srgbClr val="A4A3A4"/>
          </p15:clr>
        </p15:guide>
        <p15:guide id="8" orient="horz" pos="443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09670F-CE05-9C7F-2A18-F12607C6DEEE}" name="Eva Herrero Serrano" initials="EHS" userId="S::eh642@cam.ac.uk::30ee73c8-4441-48c1-9b41-6efa0a64ae52" providerId="AD"/>
  <p188:author id="{14A239CE-EE99-779E-A9A8-70BD1B86BCFC}" name="Alex Webb" initials="AW" userId="S::aarw2@cam.ac.uk::6e034127-e0df-4368-bc35-fbdfd215004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92"/>
    <a:srgbClr val="163E62"/>
    <a:srgbClr val="4C95D9"/>
    <a:srgbClr val="46B1E1"/>
    <a:srgbClr val="7A81FF"/>
    <a:srgbClr val="0432FF"/>
    <a:srgbClr val="163E63"/>
    <a:srgbClr val="FF8AD8"/>
    <a:srgbClr val="ECECEC"/>
    <a:srgbClr val="4D95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>
        <p:guide orient="horz" pos="1510"/>
        <p:guide pos="391"/>
        <p:guide orient="horz" pos="6136"/>
        <p:guide pos="3884"/>
        <p:guide orient="horz" pos="44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va Herrero Serrano" userId="30ee73c8-4441-48c1-9b41-6efa0a64ae52" providerId="ADAL" clId="{B52C2164-0233-5D4D-904A-27A52F1A8576}"/>
    <pc:docChg chg="delSld">
      <pc:chgData name="Eva Herrero Serrano" userId="30ee73c8-4441-48c1-9b41-6efa0a64ae52" providerId="ADAL" clId="{B52C2164-0233-5D4D-904A-27A52F1A8576}" dt="2025-07-02T13:31:37.567" v="6" actId="2696"/>
      <pc:docMkLst>
        <pc:docMk/>
      </pc:docMkLst>
      <pc:sldChg chg="del">
        <pc:chgData name="Eva Herrero Serrano" userId="30ee73c8-4441-48c1-9b41-6efa0a64ae52" providerId="ADAL" clId="{B52C2164-0233-5D4D-904A-27A52F1A8576}" dt="2025-07-02T13:31:31.970" v="0" actId="2696"/>
        <pc:sldMkLst>
          <pc:docMk/>
          <pc:sldMk cId="328607546" sldId="384"/>
        </pc:sldMkLst>
      </pc:sldChg>
      <pc:sldChg chg="del">
        <pc:chgData name="Eva Herrero Serrano" userId="30ee73c8-4441-48c1-9b41-6efa0a64ae52" providerId="ADAL" clId="{B52C2164-0233-5D4D-904A-27A52F1A8576}" dt="2025-07-02T13:31:37.567" v="6" actId="2696"/>
        <pc:sldMkLst>
          <pc:docMk/>
          <pc:sldMk cId="2380616195" sldId="400"/>
        </pc:sldMkLst>
      </pc:sldChg>
      <pc:sldChg chg="del">
        <pc:chgData name="Eva Herrero Serrano" userId="30ee73c8-4441-48c1-9b41-6efa0a64ae52" providerId="ADAL" clId="{B52C2164-0233-5D4D-904A-27A52F1A8576}" dt="2025-07-02T13:31:32.404" v="1" actId="2696"/>
        <pc:sldMkLst>
          <pc:docMk/>
          <pc:sldMk cId="548085851" sldId="404"/>
        </pc:sldMkLst>
      </pc:sldChg>
      <pc:sldChg chg="del">
        <pc:chgData name="Eva Herrero Serrano" userId="30ee73c8-4441-48c1-9b41-6efa0a64ae52" providerId="ADAL" clId="{B52C2164-0233-5D4D-904A-27A52F1A8576}" dt="2025-07-02T13:31:36.987" v="5" actId="2696"/>
        <pc:sldMkLst>
          <pc:docMk/>
          <pc:sldMk cId="2941851669" sldId="406"/>
        </pc:sldMkLst>
      </pc:sldChg>
      <pc:sldChg chg="del">
        <pc:chgData name="Eva Herrero Serrano" userId="30ee73c8-4441-48c1-9b41-6efa0a64ae52" providerId="ADAL" clId="{B52C2164-0233-5D4D-904A-27A52F1A8576}" dt="2025-07-02T13:31:32.934" v="2" actId="2696"/>
        <pc:sldMkLst>
          <pc:docMk/>
          <pc:sldMk cId="2152653418" sldId="407"/>
        </pc:sldMkLst>
      </pc:sldChg>
      <pc:sldChg chg="del">
        <pc:chgData name="Eva Herrero Serrano" userId="30ee73c8-4441-48c1-9b41-6efa0a64ae52" providerId="ADAL" clId="{B52C2164-0233-5D4D-904A-27A52F1A8576}" dt="2025-07-02T13:31:36.288" v="4" actId="2696"/>
        <pc:sldMkLst>
          <pc:docMk/>
          <pc:sldMk cId="2625866172" sldId="409"/>
        </pc:sldMkLst>
      </pc:sldChg>
      <pc:sldChg chg="del">
        <pc:chgData name="Eva Herrero Serrano" userId="30ee73c8-4441-48c1-9b41-6efa0a64ae52" providerId="ADAL" clId="{B52C2164-0233-5D4D-904A-27A52F1A8576}" dt="2025-07-02T13:31:35.568" v="3" actId="2696"/>
        <pc:sldMkLst>
          <pc:docMk/>
          <pc:sldMk cId="564929238" sldId="41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5497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0B9EA6-4523-204F-A38C-EB310BB9E6E6}" type="datetimeFigureOut">
              <a:rPr lang="en-US" smtClean="0"/>
              <a:t>7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1950" y="849313"/>
            <a:ext cx="1587500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3140" y="3269853"/>
            <a:ext cx="7945120" cy="2675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5497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65B47-02A3-6545-81BD-CE096AC3AC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78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0749-87E1-654D-9347-98A262523D99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6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A369A-2B05-6844-B0A9-E549CABD4D18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8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2C1AE-F068-A54F-BD59-F157D26CAF3B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03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A49AF-D4B1-B841-A3C6-0797BAE97B73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35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EC4B1-A988-4D40-8895-309A5922874F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04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28266-E031-EE4A-AA5B-25E86C1B8835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67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81142-A245-CD4C-98EC-FE91F66445E5}" type="datetime1">
              <a:rPr lang="en-GB" smtClean="0"/>
              <a:t>02/0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82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AF423-F805-2041-97CC-1A4994037567}" type="datetime1">
              <a:rPr lang="en-GB" smtClean="0"/>
              <a:t>02/0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45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91740-F340-7F42-A214-B550E62E5598}" type="datetime1">
              <a:rPr lang="en-GB" smtClean="0"/>
              <a:t>02/0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2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1EBA1-5261-ED4A-BA40-688502E8C4F1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586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8212F-31D4-CC4E-BBE9-0FE5E46009E3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61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F5EBD4-D993-2F4A-BC64-32375B140610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63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sv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81FE001-74F3-6217-94D7-7FDB13F4DDB2}"/>
              </a:ext>
            </a:extLst>
          </p:cNvPr>
          <p:cNvSpPr txBox="1"/>
          <p:nvPr/>
        </p:nvSpPr>
        <p:spPr>
          <a:xfrm>
            <a:off x="251686" y="192224"/>
            <a:ext cx="4071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Extended data Figure 4. TTG1 complementation lines</a:t>
            </a:r>
            <a:endParaRPr lang="en-US" i="1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AC28F9-A8FD-F1BB-80C4-D70FB3BEA30F}"/>
              </a:ext>
            </a:extLst>
          </p:cNvPr>
          <p:cNvSpPr txBox="1"/>
          <p:nvPr/>
        </p:nvSpPr>
        <p:spPr>
          <a:xfrm>
            <a:off x="315256" y="2690183"/>
            <a:ext cx="235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CFAD00C-0D41-AE4F-6F66-4F5F25DD53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371" y="4179251"/>
            <a:ext cx="2156400" cy="106954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36915D1-58D6-A5EE-57E7-65BECD30993E}"/>
              </a:ext>
            </a:extLst>
          </p:cNvPr>
          <p:cNvSpPr txBox="1"/>
          <p:nvPr/>
        </p:nvSpPr>
        <p:spPr>
          <a:xfrm>
            <a:off x="706504" y="2812752"/>
            <a:ext cx="21612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900" b="1" 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/>
              <a:t>ttg1-21 pTTG1::Venus-TTG1 </a:t>
            </a:r>
            <a:r>
              <a:rPr lang="en-US" i="0"/>
              <a:t>line 1</a:t>
            </a:r>
            <a:endParaRPr lang="en-GB" i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4F6A71A-9BD1-84EE-51DD-34FFF04D8818}"/>
              </a:ext>
            </a:extLst>
          </p:cNvPr>
          <p:cNvSpPr txBox="1"/>
          <p:nvPr/>
        </p:nvSpPr>
        <p:spPr>
          <a:xfrm rot="16200000">
            <a:off x="65868" y="3479570"/>
            <a:ext cx="1065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Venu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BDE48F6-20DF-25CB-EBB9-24A291467A44}"/>
              </a:ext>
            </a:extLst>
          </p:cNvPr>
          <p:cNvSpPr txBox="1"/>
          <p:nvPr/>
        </p:nvSpPr>
        <p:spPr>
          <a:xfrm rot="16200000">
            <a:off x="2433869" y="3479570"/>
            <a:ext cx="1065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Brightfield</a:t>
            </a:r>
          </a:p>
        </p:txBody>
      </p:sp>
      <p:pic>
        <p:nvPicPr>
          <p:cNvPr id="21" name="Picture 20" descr="A close up of a microscope&#10;&#10;Description automatically generated">
            <a:extLst>
              <a:ext uri="{FF2B5EF4-FFF2-40B4-BE49-F238E27FC236}">
                <a16:creationId xmlns:a16="http://schemas.microsoft.com/office/drawing/2014/main" id="{9DF6BA15-4D4A-74AE-2D84-00F6133114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1371" y="3055267"/>
            <a:ext cx="2156400" cy="1064051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0A8894DD-1D0B-5932-9B03-AA67AAC81295}"/>
              </a:ext>
            </a:extLst>
          </p:cNvPr>
          <p:cNvSpPr txBox="1"/>
          <p:nvPr/>
        </p:nvSpPr>
        <p:spPr>
          <a:xfrm rot="16200000">
            <a:off x="76789" y="4606302"/>
            <a:ext cx="1065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Venu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ACD5C73-FAA5-23E3-3A29-A4A76D9FF5FF}"/>
              </a:ext>
            </a:extLst>
          </p:cNvPr>
          <p:cNvSpPr txBox="1"/>
          <p:nvPr/>
        </p:nvSpPr>
        <p:spPr>
          <a:xfrm rot="16200000">
            <a:off x="2444790" y="4606302"/>
            <a:ext cx="1065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Brightfiel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2B55E-D006-1B59-B71D-B54A8D0C404B}"/>
              </a:ext>
            </a:extLst>
          </p:cNvPr>
          <p:cNvSpPr txBox="1"/>
          <p:nvPr/>
        </p:nvSpPr>
        <p:spPr>
          <a:xfrm>
            <a:off x="3651807" y="2806669"/>
            <a:ext cx="215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i="1">
                <a:latin typeface="Arial" panose="020B0604020202020204" pitchFamily="34" charset="0"/>
                <a:cs typeface="Arial" panose="020B0604020202020204" pitchFamily="34" charset="0"/>
              </a:rPr>
              <a:t>ttg1-21 pTTG1::Venus-TTG1 </a:t>
            </a:r>
            <a:r>
              <a:rPr lang="en-US" sz="900" b="1">
                <a:latin typeface="Arial" panose="020B0604020202020204" pitchFamily="34" charset="0"/>
                <a:cs typeface="Arial" panose="020B0604020202020204" pitchFamily="34" charset="0"/>
              </a:rPr>
              <a:t>line 2</a:t>
            </a:r>
            <a:endParaRPr lang="en-GB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BA2FE2E-6065-962B-91DA-17A76B00B591}"/>
              </a:ext>
            </a:extLst>
          </p:cNvPr>
          <p:cNvSpPr txBox="1"/>
          <p:nvPr/>
        </p:nvSpPr>
        <p:spPr>
          <a:xfrm rot="16200000">
            <a:off x="3002158" y="3475589"/>
            <a:ext cx="1065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Venu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6E31854-FC9A-AABE-4EB1-A6C82BA80D02}"/>
              </a:ext>
            </a:extLst>
          </p:cNvPr>
          <p:cNvSpPr txBox="1"/>
          <p:nvPr/>
        </p:nvSpPr>
        <p:spPr>
          <a:xfrm rot="16200000">
            <a:off x="5347248" y="3475589"/>
            <a:ext cx="1065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Brightfield</a:t>
            </a:r>
          </a:p>
        </p:txBody>
      </p:sp>
      <p:pic>
        <p:nvPicPr>
          <p:cNvPr id="23" name="Picture 22" descr="A close up of a microscope&#10;&#10;Description automatically generated">
            <a:extLst>
              <a:ext uri="{FF2B5EF4-FFF2-40B4-BE49-F238E27FC236}">
                <a16:creationId xmlns:a16="http://schemas.microsoft.com/office/drawing/2014/main" id="{475A0DCD-CC0D-6448-2AC0-F38476CFC8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1807" y="3051286"/>
            <a:ext cx="2156400" cy="1064050"/>
          </a:xfrm>
          <a:prstGeom prst="rect">
            <a:avLst/>
          </a:prstGeom>
        </p:spPr>
      </p:pic>
      <p:pic>
        <p:nvPicPr>
          <p:cNvPr id="25" name="Picture 24" descr="A close up of a cell&#10;&#10;Description automatically generated">
            <a:extLst>
              <a:ext uri="{FF2B5EF4-FFF2-40B4-BE49-F238E27FC236}">
                <a16:creationId xmlns:a16="http://schemas.microsoft.com/office/drawing/2014/main" id="{65C0AA45-F480-CD93-310B-8C863C1572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1807" y="4186750"/>
            <a:ext cx="2156400" cy="106405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F522E919-F6E7-5613-D777-96B88C7FD6D7}"/>
              </a:ext>
            </a:extLst>
          </p:cNvPr>
          <p:cNvSpPr txBox="1"/>
          <p:nvPr/>
        </p:nvSpPr>
        <p:spPr>
          <a:xfrm rot="16200000">
            <a:off x="3002159" y="4611053"/>
            <a:ext cx="1065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Venu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8105366-99D2-DED1-C7FE-7D36652C965F}"/>
              </a:ext>
            </a:extLst>
          </p:cNvPr>
          <p:cNvSpPr txBox="1"/>
          <p:nvPr/>
        </p:nvSpPr>
        <p:spPr>
          <a:xfrm rot="16200000">
            <a:off x="5347249" y="4611053"/>
            <a:ext cx="1065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Brightfiel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03086CA-079F-1EDE-D525-FE6DB0B08A2A}"/>
              </a:ext>
            </a:extLst>
          </p:cNvPr>
          <p:cNvSpPr txBox="1"/>
          <p:nvPr/>
        </p:nvSpPr>
        <p:spPr>
          <a:xfrm>
            <a:off x="315256" y="596999"/>
            <a:ext cx="235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6CF0657-FD62-1055-AD75-173ECEEA866B}"/>
              </a:ext>
            </a:extLst>
          </p:cNvPr>
          <p:cNvSpPr txBox="1"/>
          <p:nvPr/>
        </p:nvSpPr>
        <p:spPr>
          <a:xfrm>
            <a:off x="315256" y="5432496"/>
            <a:ext cx="235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4C63E808-9E02-02E7-5E12-F33043BFADED}"/>
              </a:ext>
            </a:extLst>
          </p:cNvPr>
          <p:cNvGrpSpPr/>
          <p:nvPr/>
        </p:nvGrpSpPr>
        <p:grpSpPr>
          <a:xfrm>
            <a:off x="3617961" y="728351"/>
            <a:ext cx="2681828" cy="845712"/>
            <a:chOff x="3426794" y="880619"/>
            <a:chExt cx="2681828" cy="845712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0DE2297-3702-12F2-5946-AC2ED9C0B402}"/>
                </a:ext>
              </a:extLst>
            </p:cNvPr>
            <p:cNvSpPr txBox="1"/>
            <p:nvPr/>
          </p:nvSpPr>
          <p:spPr>
            <a:xfrm>
              <a:off x="3642794" y="1495499"/>
              <a:ext cx="2465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>
                  <a:latin typeface="Arial" panose="020B0604020202020204" pitchFamily="34" charset="0"/>
                  <a:cs typeface="Arial" panose="020B0604020202020204" pitchFamily="34" charset="0"/>
                </a:rPr>
                <a:t>ttg1-21 pTTG1::Venus-TTG1 </a:t>
              </a:r>
              <a:r>
                <a:rPr lang="en-US" sz="900" b="1">
                  <a:latin typeface="Arial" panose="020B0604020202020204" pitchFamily="34" charset="0"/>
                  <a:cs typeface="Arial" panose="020B0604020202020204" pitchFamily="34" charset="0"/>
                </a:rPr>
                <a:t>line 2</a:t>
              </a:r>
              <a:endParaRPr lang="en-GB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4D26004-4D40-0516-3E70-78388640DB91}"/>
                </a:ext>
              </a:extLst>
            </p:cNvPr>
            <p:cNvSpPr txBox="1"/>
            <p:nvPr/>
          </p:nvSpPr>
          <p:spPr>
            <a:xfrm>
              <a:off x="3642794" y="1329616"/>
              <a:ext cx="2465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>
                  <a:latin typeface="Arial" panose="020B0604020202020204" pitchFamily="34" charset="0"/>
                  <a:cs typeface="Arial" panose="020B0604020202020204" pitchFamily="34" charset="0"/>
                </a:rPr>
                <a:t>ttg1-21 pTTG1::Venus-TTG1 </a:t>
              </a:r>
              <a:r>
                <a:rPr lang="en-US" sz="900" b="1">
                  <a:latin typeface="Arial" panose="020B0604020202020204" pitchFamily="34" charset="0"/>
                  <a:cs typeface="Arial" panose="020B0604020202020204" pitchFamily="34" charset="0"/>
                </a:rPr>
                <a:t>line 1</a:t>
              </a:r>
              <a:endParaRPr lang="en-GB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C2A8109-7E2F-7E66-F576-DBE806F2EB55}"/>
                </a:ext>
              </a:extLst>
            </p:cNvPr>
            <p:cNvSpPr txBox="1"/>
            <p:nvPr/>
          </p:nvSpPr>
          <p:spPr>
            <a:xfrm>
              <a:off x="3642794" y="1158372"/>
              <a:ext cx="2465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>
                  <a:latin typeface="Arial" panose="020B0604020202020204" pitchFamily="34" charset="0"/>
                  <a:cs typeface="Arial" panose="020B0604020202020204" pitchFamily="34" charset="0"/>
                </a:rPr>
                <a:t>ttg1-21</a:t>
              </a:r>
              <a:endParaRPr lang="en-GB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435D7F0-60DF-F406-F589-C8A364F4B4EC}"/>
                </a:ext>
              </a:extLst>
            </p:cNvPr>
            <p:cNvSpPr txBox="1"/>
            <p:nvPr/>
          </p:nvSpPr>
          <p:spPr>
            <a:xfrm>
              <a:off x="3642794" y="984310"/>
              <a:ext cx="24658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>
                  <a:latin typeface="Arial" panose="020B0604020202020204" pitchFamily="34" charset="0"/>
                  <a:cs typeface="Arial" panose="020B0604020202020204" pitchFamily="34" charset="0"/>
                </a:rPr>
                <a:t>wild type</a:t>
              </a:r>
              <a:endParaRPr lang="en-GB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7" name="Graphic 36">
              <a:extLst>
                <a:ext uri="{FF2B5EF4-FFF2-40B4-BE49-F238E27FC236}">
                  <a16:creationId xmlns:a16="http://schemas.microsoft.com/office/drawing/2014/main" id="{76BA1686-C992-CB9A-E638-ECFA46DEA6D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rcRect l="67206" t="28504" r="29104" b="49743"/>
            <a:stretch/>
          </p:blipFill>
          <p:spPr>
            <a:xfrm>
              <a:off x="3426794" y="880619"/>
              <a:ext cx="216000" cy="831478"/>
            </a:xfrm>
            <a:prstGeom prst="rect">
              <a:avLst/>
            </a:prstGeom>
          </p:spPr>
        </p:pic>
      </p:grpSp>
      <p:sp>
        <p:nvSpPr>
          <p:cNvPr id="33" name="Rectangle 32">
            <a:extLst>
              <a:ext uri="{FF2B5EF4-FFF2-40B4-BE49-F238E27FC236}">
                <a16:creationId xmlns:a16="http://schemas.microsoft.com/office/drawing/2014/main" id="{61402534-BB29-F4F7-A621-76EE6610BAA3}"/>
              </a:ext>
            </a:extLst>
          </p:cNvPr>
          <p:cNvSpPr/>
          <p:nvPr/>
        </p:nvSpPr>
        <p:spPr>
          <a:xfrm>
            <a:off x="1210325" y="866309"/>
            <a:ext cx="2286000" cy="50507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6" name="Graphic 35">
            <a:extLst>
              <a:ext uri="{FF2B5EF4-FFF2-40B4-BE49-F238E27FC236}">
                <a16:creationId xmlns:a16="http://schemas.microsoft.com/office/drawing/2014/main" id="{61F32A80-62CA-7429-65AB-13C83C45F98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1" t="28504" r="35935" b="9435"/>
          <a:stretch/>
        </p:blipFill>
        <p:spPr>
          <a:xfrm>
            <a:off x="709482" y="750737"/>
            <a:ext cx="2919835" cy="1769127"/>
          </a:xfrm>
          <a:prstGeom prst="rect">
            <a:avLst/>
          </a:prstGeom>
        </p:spPr>
      </p:pic>
      <p:sp>
        <p:nvSpPr>
          <p:cNvPr id="39" name="Rectangle 38">
            <a:extLst>
              <a:ext uri="{FF2B5EF4-FFF2-40B4-BE49-F238E27FC236}">
                <a16:creationId xmlns:a16="http://schemas.microsoft.com/office/drawing/2014/main" id="{B6360C89-678F-949E-3194-6BABE00C2A41}"/>
              </a:ext>
            </a:extLst>
          </p:cNvPr>
          <p:cNvSpPr/>
          <p:nvPr/>
        </p:nvSpPr>
        <p:spPr>
          <a:xfrm>
            <a:off x="1448450" y="866309"/>
            <a:ext cx="137160" cy="5050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D9EB2EEB-E625-8FD6-C3C0-E0164ADFDF0F}"/>
              </a:ext>
            </a:extLst>
          </p:cNvPr>
          <p:cNvSpPr/>
          <p:nvPr/>
        </p:nvSpPr>
        <p:spPr>
          <a:xfrm>
            <a:off x="1827069" y="866309"/>
            <a:ext cx="137160" cy="5050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AE4A5D90-DE18-EB94-D392-671770A3CCE2}"/>
              </a:ext>
            </a:extLst>
          </p:cNvPr>
          <p:cNvSpPr/>
          <p:nvPr/>
        </p:nvSpPr>
        <p:spPr>
          <a:xfrm>
            <a:off x="2212414" y="866309"/>
            <a:ext cx="137160" cy="5050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121359F-E990-7C38-DC69-190BA30CA069}"/>
              </a:ext>
            </a:extLst>
          </p:cNvPr>
          <p:cNvSpPr txBox="1"/>
          <p:nvPr/>
        </p:nvSpPr>
        <p:spPr>
          <a:xfrm>
            <a:off x="1584152" y="2426490"/>
            <a:ext cx="10129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>
                <a:latin typeface="Arial" panose="020B0604020202020204" pitchFamily="34" charset="0"/>
                <a:cs typeface="Arial" panose="020B0604020202020204" pitchFamily="34" charset="0"/>
              </a:rPr>
              <a:t>Time (hours)</a:t>
            </a:r>
            <a:endParaRPr lang="en-GB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8CC6051-3F25-9B14-AD60-14BE8136BC6C}"/>
              </a:ext>
            </a:extLst>
          </p:cNvPr>
          <p:cNvSpPr txBox="1"/>
          <p:nvPr/>
        </p:nvSpPr>
        <p:spPr>
          <a:xfrm rot="16200000">
            <a:off x="-299067" y="1449215"/>
            <a:ext cx="19325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>
                <a:latin typeface="Arial" panose="020B0604020202020204" pitchFamily="34" charset="0"/>
                <a:cs typeface="Arial" panose="020B0604020202020204" pitchFamily="34" charset="0"/>
              </a:rPr>
              <a:t>Bioluminescence </a:t>
            </a:r>
            <a:r>
              <a:rPr lang="en-US" sz="900" b="1" i="1">
                <a:latin typeface="Arial" panose="020B0604020202020204" pitchFamily="34" charset="0"/>
                <a:cs typeface="Arial" panose="020B0604020202020204" pitchFamily="34" charset="0"/>
              </a:rPr>
              <a:t>pCCA1::LUC </a:t>
            </a:r>
            <a:endParaRPr lang="en-GB" sz="9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Graphic 45">
            <a:extLst>
              <a:ext uri="{FF2B5EF4-FFF2-40B4-BE49-F238E27FC236}">
                <a16:creationId xmlns:a16="http://schemas.microsoft.com/office/drawing/2014/main" id="{690BA815-FC8D-3165-55A7-38610B95FE2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547349" y="5661041"/>
            <a:ext cx="5760000" cy="24766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4589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</Words>
  <Application>Microsoft Macintosh PowerPoint</Application>
  <PresentationFormat>A4 Paper (210x297 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Herrero Serrano</dc:creator>
  <cp:lastModifiedBy>Eva Herrero Serrano</cp:lastModifiedBy>
  <cp:revision>2</cp:revision>
  <cp:lastPrinted>2025-07-02T13:25:36Z</cp:lastPrinted>
  <dcterms:created xsi:type="dcterms:W3CDTF">2024-05-20T09:44:22Z</dcterms:created>
  <dcterms:modified xsi:type="dcterms:W3CDTF">2025-07-02T13:31:38Z</dcterms:modified>
</cp:coreProperties>
</file>